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514" r:id="rId2"/>
    <p:sldId id="609" r:id="rId3"/>
    <p:sldId id="610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7" d="100"/>
          <a:sy n="77" d="100"/>
        </p:scale>
        <p:origin x="68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AD18E8-0A6C-EFA0-1085-60D041D062D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D6E2332-B14F-7E3F-81E4-25DFE95C91F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3200A67-CB56-94DE-F16D-E150657549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65180-EEEB-49B6-815A-247B7664DE16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328CD0-7BE6-21E5-B528-81D83AC85F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ECACC0-67DA-E858-EEE5-86C23D10D64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16914-F368-4948-8CDB-A54059CA5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6629640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35D2F7-4E8C-EAFE-7353-FD00B11F840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1340A81-73D7-6777-34CB-2102BED14BF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DA4B7FF-09F1-7A3D-93CF-E13145B19F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65180-EEEB-49B6-815A-247B7664DE16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4940848-FEC5-541B-3C9A-6817EFA3FA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C1D18E5-0B7D-7CA5-F2DB-D03520506AB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16914-F368-4948-8CDB-A54059CA5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10649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1B916EB-734B-81C4-60BD-129089B03B4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71AE7538-7257-FEC1-90BD-F5CF72F2DDC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F502160-60C5-AB86-B5E4-FC0AD9A0B4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65180-EEEB-49B6-815A-247B7664DE16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74AC948-D318-DC75-4500-B163B5BA49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951156-A7D1-ACB1-078D-7558A61526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16914-F368-4948-8CDB-A54059CA5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02356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2E4A694-C8BD-DDBC-59C8-291040319D8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0C4D640-BB61-88EE-AE72-2616D80D687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89E2D2A-2CE6-8BB7-F23E-A75E93312A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65180-EEEB-49B6-815A-247B7664DE16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1C71ADC-C7B3-5524-78AA-9B2F6ADA5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1751FA-B2A4-0D4B-842A-25F4422F64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16914-F368-4948-8CDB-A54059CA5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78304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B07880D-440D-A85B-8149-092F6924F5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D054C6C6-B034-60C4-EBAD-AE69B6848B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25FF17-0210-E2B7-5011-C4586BD5190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65180-EEEB-49B6-815A-247B7664DE16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576721D-DE3C-2B66-D005-D8232564FB4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1D6D8DC-F326-E129-405A-C0E7B41310F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16914-F368-4948-8CDB-A54059CA5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83271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97DA9A-B3DE-E387-BB83-E4978716E3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02E29F6-E7AA-8FD8-1439-0EADDF3DE33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079636C-4A21-D766-C90B-3AD530D9103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ED3EBE7-28EB-624A-4E75-16F4B5FF4E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65180-EEEB-49B6-815A-247B7664DE16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4289018-9B03-F054-03AC-6DDF9FD1F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D53F206-C2B1-EEB9-A846-A3B7976394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16914-F368-4948-8CDB-A54059CA5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14081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1B16DCC-1900-54B8-775E-374B215A50A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31683C-0AD6-CF1E-2BB3-731868BF7C5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9E1ACF4-0C22-CEC1-ADFF-6267D8CCD21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BD0C5DC-6630-E56C-61C8-702653C6710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8881F779-E1F7-6F4B-E2E0-75FDA3F259B0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4398346-B136-EB92-5163-9E6CE62D8E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65180-EEEB-49B6-815A-247B7664DE16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A4A0FC2-17A2-9A2B-51FB-9B3DB00690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FE0E7DF2-726A-6D9A-DC1B-8336E9545F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16914-F368-4948-8CDB-A54059CA5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25291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1D9921-C18B-9D0F-3C5A-39BF103F705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E071C0E-D729-5AF6-D048-9FE614516F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65180-EEEB-49B6-815A-247B7664DE16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C69D00A-12EA-191B-5943-99C969E2413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66545BB-46AB-CCED-470A-DB1E359E70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16914-F368-4948-8CDB-A54059CA5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61055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4FF5AD4B-D907-650F-CE2C-245992EEDB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65180-EEEB-49B6-815A-247B7664DE16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BDB9838-42AF-D271-85C9-A094FA08E89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46104B3-7D82-76F4-C00F-0B978046AF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16914-F368-4948-8CDB-A54059CA5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982817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600ED3-0499-976D-0ACC-1EAD660E3E2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50FC7EE-5348-2F28-E18A-4D5393E51BB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5E54D1-5B60-EA50-86C3-60D4E1764C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4ADCE41-E0F2-2463-9B74-2B45769B6F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65180-EEEB-49B6-815A-247B7664DE16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DB0E817-6113-6820-9A25-F2F3D8F5AF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172CABC-647A-E2D0-4849-D551B7B1C15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16914-F368-4948-8CDB-A54059CA5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53288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54C554-F47D-16C7-3EB6-5B6C8DF727B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5698F05-294A-A493-AE0A-B53D9C0634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5895BBC-BFEC-74BE-B61D-027E82B6FE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3EE1412-6323-AAB4-BBC2-CD5B7CCD2B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0B65180-EEEB-49B6-815A-247B7664DE16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900A5EE-5066-ADE4-600B-5BF429B0D58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9AAEAD-E2C8-B593-A055-AF36F7F7C3B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4E16914-F368-4948-8CDB-A54059CA5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68952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2720A460-153D-2D7D-6797-AB25F47CDDA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278090A-5586-FC3F-C6CD-AC9651E9A92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4F89EFF-0D9A-876B-C45F-96B8E14BAED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B65180-EEEB-49B6-815A-247B7664DE16}" type="datetimeFigureOut">
              <a:rPr lang="en-US" smtClean="0"/>
              <a:t>4/17/20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F401CD-D93E-A706-23DE-C915064FE6A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AC04F2-B878-37CC-C4D3-A12A788E50B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4E16914-F368-4948-8CDB-A54059CA5D4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264715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738495CF-5ADE-3D01-36F2-05360382D40C}"/>
              </a:ext>
            </a:extLst>
          </p:cNvPr>
          <p:cNvSpPr txBox="1"/>
          <p:nvPr/>
        </p:nvSpPr>
        <p:spPr>
          <a:xfrm rot="18900000">
            <a:off x="4900799" y="1226350"/>
            <a:ext cx="21090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siCO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494284C-BD05-A29E-EA30-21031999CCA8}"/>
              </a:ext>
            </a:extLst>
          </p:cNvPr>
          <p:cNvSpPr txBox="1"/>
          <p:nvPr/>
        </p:nvSpPr>
        <p:spPr>
          <a:xfrm rot="18900000">
            <a:off x="5745235" y="1214223"/>
            <a:ext cx="22518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iALKBH5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E34E89C5-19ED-9402-5C79-B498D43AC6DC}"/>
              </a:ext>
            </a:extLst>
          </p:cNvPr>
          <p:cNvSpPr txBox="1"/>
          <p:nvPr/>
        </p:nvSpPr>
        <p:spPr>
          <a:xfrm rot="18900000">
            <a:off x="6865607" y="1205253"/>
            <a:ext cx="21090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siCO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794185F0-EC28-F69F-6A04-1365F083A7AE}"/>
              </a:ext>
            </a:extLst>
          </p:cNvPr>
          <p:cNvSpPr txBox="1"/>
          <p:nvPr/>
        </p:nvSpPr>
        <p:spPr>
          <a:xfrm rot="18900000">
            <a:off x="7710043" y="1193126"/>
            <a:ext cx="22518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iALKBH5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1B3C5CA-59FD-1F94-45CB-ADD4D873228E}"/>
              </a:ext>
            </a:extLst>
          </p:cNvPr>
          <p:cNvSpPr txBox="1"/>
          <p:nvPr/>
        </p:nvSpPr>
        <p:spPr>
          <a:xfrm rot="18900000">
            <a:off x="11137489" y="1217071"/>
            <a:ext cx="21090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shCO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EA883FB8-A762-C377-44E4-17CC11002FDC}"/>
              </a:ext>
            </a:extLst>
          </p:cNvPr>
          <p:cNvSpPr txBox="1"/>
          <p:nvPr/>
        </p:nvSpPr>
        <p:spPr>
          <a:xfrm rot="18900000">
            <a:off x="11787533" y="1205252"/>
            <a:ext cx="22518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hALKBH5</a:t>
            </a:r>
          </a:p>
        </p:txBody>
      </p:sp>
      <p:pic>
        <p:nvPicPr>
          <p:cNvPr id="12" name="Picture 11" descr="A picture containing text&#10;&#10;Description automatically generated">
            <a:extLst>
              <a:ext uri="{FF2B5EF4-FFF2-40B4-BE49-F238E27FC236}">
                <a16:creationId xmlns:a16="http://schemas.microsoft.com/office/drawing/2014/main" id="{BDA1A83C-D8B9-00D6-C0AB-E3AF9B867897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7632" t="31031" r="25696" b="61467"/>
          <a:stretch/>
        </p:blipFill>
        <p:spPr>
          <a:xfrm rot="186444">
            <a:off x="2948960" y="2898486"/>
            <a:ext cx="9792419" cy="1061029"/>
          </a:xfrm>
          <a:custGeom>
            <a:avLst/>
            <a:gdLst>
              <a:gd name="connsiteX0" fmla="*/ 0 w 9792419"/>
              <a:gd name="connsiteY0" fmla="*/ 515661 h 1061029"/>
              <a:gd name="connsiteX1" fmla="*/ 9498683 w 9792419"/>
              <a:gd name="connsiteY1" fmla="*/ 0 h 1061029"/>
              <a:gd name="connsiteX2" fmla="*/ 9763591 w 9792419"/>
              <a:gd name="connsiteY2" fmla="*/ 0 h 1061029"/>
              <a:gd name="connsiteX3" fmla="*/ 9792419 w 9792419"/>
              <a:gd name="connsiteY3" fmla="*/ 531029 h 1061029"/>
              <a:gd name="connsiteX4" fmla="*/ 29607 w 9792419"/>
              <a:gd name="connsiteY4" fmla="*/ 1061029 h 1061029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9792419" h="1061029">
                <a:moveTo>
                  <a:pt x="0" y="515661"/>
                </a:moveTo>
                <a:lnTo>
                  <a:pt x="9498683" y="0"/>
                </a:lnTo>
                <a:lnTo>
                  <a:pt x="9763591" y="0"/>
                </a:lnTo>
                <a:lnTo>
                  <a:pt x="9792419" y="531029"/>
                </a:lnTo>
                <a:lnTo>
                  <a:pt x="29607" y="1061029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</p:pic>
      <p:pic>
        <p:nvPicPr>
          <p:cNvPr id="13" name="Picture 12" descr="A picture containing text&#10;&#10;Description automatically generated">
            <a:extLst>
              <a:ext uri="{FF2B5EF4-FFF2-40B4-BE49-F238E27FC236}">
                <a16:creationId xmlns:a16="http://schemas.microsoft.com/office/drawing/2014/main" id="{91976603-35A1-6961-4061-A34D251F6E7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5147" t="37222" r="19778" b="57605"/>
          <a:stretch/>
        </p:blipFill>
        <p:spPr>
          <a:xfrm>
            <a:off x="2851326" y="2258435"/>
            <a:ext cx="11467902" cy="778909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163D0C2A-D4A4-6E6D-B03B-DC97B883E964}"/>
              </a:ext>
            </a:extLst>
          </p:cNvPr>
          <p:cNvSpPr txBox="1"/>
          <p:nvPr/>
        </p:nvSpPr>
        <p:spPr>
          <a:xfrm rot="18900000">
            <a:off x="2788116" y="1097486"/>
            <a:ext cx="21090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siCO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2AC1ECB1-AE45-05A5-E796-83376A404CF5}"/>
              </a:ext>
            </a:extLst>
          </p:cNvPr>
          <p:cNvSpPr txBox="1"/>
          <p:nvPr/>
        </p:nvSpPr>
        <p:spPr>
          <a:xfrm rot="18900000">
            <a:off x="3632552" y="1085359"/>
            <a:ext cx="22518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iALKBH5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A4250F98-7D23-D771-1BCB-527D595E03F4}"/>
              </a:ext>
            </a:extLst>
          </p:cNvPr>
          <p:cNvSpPr txBox="1"/>
          <p:nvPr/>
        </p:nvSpPr>
        <p:spPr>
          <a:xfrm>
            <a:off x="2015808" y="3225555"/>
            <a:ext cx="109350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GAPDH</a:t>
            </a:r>
          </a:p>
        </p:txBody>
      </p:sp>
      <p:sp>
        <p:nvSpPr>
          <p:cNvPr id="17" name="文本框 46">
            <a:extLst>
              <a:ext uri="{FF2B5EF4-FFF2-40B4-BE49-F238E27FC236}">
                <a16:creationId xmlns:a16="http://schemas.microsoft.com/office/drawing/2014/main" id="{A85311DC-6B6D-944B-3DD8-EDFEE9D187E6}"/>
              </a:ext>
            </a:extLst>
          </p:cNvPr>
          <p:cNvSpPr txBox="1"/>
          <p:nvPr/>
        </p:nvSpPr>
        <p:spPr>
          <a:xfrm>
            <a:off x="1712622" y="2464576"/>
            <a:ext cx="96853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600" dirty="0">
                <a:latin typeface="Arial" panose="020B0604020202020204" pitchFamily="34" charset="0"/>
                <a:cs typeface="Arial" panose="020B0604020202020204" pitchFamily="34" charset="0"/>
              </a:rPr>
              <a:t>ALKBH5</a:t>
            </a:r>
            <a:endParaRPr kumimoji="1" lang="zh-CN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7612CEC1-FF45-2B3F-F28F-BC14016DFA11}"/>
              </a:ext>
            </a:extLst>
          </p:cNvPr>
          <p:cNvSpPr txBox="1"/>
          <p:nvPr/>
        </p:nvSpPr>
        <p:spPr>
          <a:xfrm rot="18900000">
            <a:off x="9791452" y="1160648"/>
            <a:ext cx="210902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 err="1">
                <a:latin typeface="Arial" panose="020B0604020202020204" pitchFamily="34" charset="0"/>
                <a:cs typeface="Arial" panose="020B0604020202020204" pitchFamily="34" charset="0"/>
              </a:rPr>
              <a:t>shCO</a:t>
            </a:r>
            <a:r>
              <a:rPr lang="en-US" altLang="zh-CN" sz="1600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endParaRPr 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2822BF32-C20A-0DBE-C8F7-4C4739F8F384}"/>
              </a:ext>
            </a:extLst>
          </p:cNvPr>
          <p:cNvSpPr txBox="1"/>
          <p:nvPr/>
        </p:nvSpPr>
        <p:spPr>
          <a:xfrm rot="18900000">
            <a:off x="8989526" y="1186144"/>
            <a:ext cx="2251828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" panose="020B0604020202020204" pitchFamily="34" charset="0"/>
                <a:cs typeface="Arial" panose="020B0604020202020204" pitchFamily="34" charset="0"/>
              </a:rPr>
              <a:t>shALKBH5</a:t>
            </a:r>
          </a:p>
        </p:txBody>
      </p:sp>
    </p:spTree>
    <p:extLst>
      <p:ext uri="{BB962C8B-B14F-4D97-AF65-F5344CB8AC3E}">
        <p14:creationId xmlns:p14="http://schemas.microsoft.com/office/powerpoint/2010/main" val="193807673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text&#10;&#10;Description automatically generated">
            <a:extLst>
              <a:ext uri="{FF2B5EF4-FFF2-40B4-BE49-F238E27FC236}">
                <a16:creationId xmlns:a16="http://schemas.microsoft.com/office/drawing/2014/main" id="{B6702AB5-3D99-D65F-7948-AC67EF9BF772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4547" t="32133" r="54270" b="62627"/>
          <a:stretch/>
        </p:blipFill>
        <p:spPr>
          <a:xfrm>
            <a:off x="3826566" y="2445884"/>
            <a:ext cx="1311965" cy="503093"/>
          </a:xfrm>
          <a:custGeom>
            <a:avLst/>
            <a:gdLst>
              <a:gd name="connsiteX0" fmla="*/ 0 w 1311965"/>
              <a:gd name="connsiteY0" fmla="*/ 0 h 503093"/>
              <a:gd name="connsiteX1" fmla="*/ 1311965 w 1311965"/>
              <a:gd name="connsiteY1" fmla="*/ 0 h 503093"/>
              <a:gd name="connsiteX2" fmla="*/ 1311965 w 1311965"/>
              <a:gd name="connsiteY2" fmla="*/ 503093 h 503093"/>
              <a:gd name="connsiteX3" fmla="*/ 0 w 1311965"/>
              <a:gd name="connsiteY3" fmla="*/ 503093 h 5030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11965" h="503093">
                <a:moveTo>
                  <a:pt x="0" y="0"/>
                </a:moveTo>
                <a:lnTo>
                  <a:pt x="1311965" y="0"/>
                </a:lnTo>
                <a:lnTo>
                  <a:pt x="1311965" y="503093"/>
                </a:lnTo>
                <a:lnTo>
                  <a:pt x="0" y="503093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DD5463AE-775D-B85A-A716-B6E8CA63C57E}"/>
              </a:ext>
            </a:extLst>
          </p:cNvPr>
          <p:cNvSpPr txBox="1"/>
          <p:nvPr/>
        </p:nvSpPr>
        <p:spPr>
          <a:xfrm>
            <a:off x="5181600" y="2512764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LKBH5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B6A3E62-7E30-4F43-EAD6-3BB228C1A0A5}"/>
              </a:ext>
            </a:extLst>
          </p:cNvPr>
          <p:cNvSpPr txBox="1"/>
          <p:nvPr/>
        </p:nvSpPr>
        <p:spPr>
          <a:xfrm>
            <a:off x="9320451" y="5271654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022-11- 15 </a:t>
            </a:r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wyt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9" name="Picture 8" descr="A picture containing text&#10;&#10;Description automatically generated">
            <a:extLst>
              <a:ext uri="{FF2B5EF4-FFF2-40B4-BE49-F238E27FC236}">
                <a16:creationId xmlns:a16="http://schemas.microsoft.com/office/drawing/2014/main" id="{E315966F-5696-438C-853B-39F16945BCF5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89" t="23849" r="49437" b="70494"/>
          <a:stretch/>
        </p:blipFill>
        <p:spPr>
          <a:xfrm>
            <a:off x="3826566" y="3022353"/>
            <a:ext cx="1311965" cy="503093"/>
          </a:xfrm>
          <a:custGeom>
            <a:avLst/>
            <a:gdLst>
              <a:gd name="connsiteX0" fmla="*/ 0 w 1311965"/>
              <a:gd name="connsiteY0" fmla="*/ 0 h 503093"/>
              <a:gd name="connsiteX1" fmla="*/ 1311965 w 1311965"/>
              <a:gd name="connsiteY1" fmla="*/ 0 h 503093"/>
              <a:gd name="connsiteX2" fmla="*/ 1311965 w 1311965"/>
              <a:gd name="connsiteY2" fmla="*/ 503093 h 503093"/>
              <a:gd name="connsiteX3" fmla="*/ 0 w 1311965"/>
              <a:gd name="connsiteY3" fmla="*/ 503093 h 50309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11965" h="503093">
                <a:moveTo>
                  <a:pt x="0" y="0"/>
                </a:moveTo>
                <a:lnTo>
                  <a:pt x="1311965" y="0"/>
                </a:lnTo>
                <a:lnTo>
                  <a:pt x="1311965" y="503093"/>
                </a:lnTo>
                <a:lnTo>
                  <a:pt x="0" y="503093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13EDB64-F286-6D23-14C7-10CCB5B1F1DB}"/>
              </a:ext>
            </a:extLst>
          </p:cNvPr>
          <p:cNvSpPr txBox="1"/>
          <p:nvPr/>
        </p:nvSpPr>
        <p:spPr>
          <a:xfrm>
            <a:off x="5181600" y="3089234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8C107C1-8718-7EA2-6F80-D4F26E042E5D}"/>
              </a:ext>
            </a:extLst>
          </p:cNvPr>
          <p:cNvSpPr txBox="1"/>
          <p:nvPr/>
        </p:nvSpPr>
        <p:spPr>
          <a:xfrm>
            <a:off x="3352800" y="2498548"/>
            <a:ext cx="473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C79E4A0-8E02-35D6-7B0D-14ECAA09FD21}"/>
              </a:ext>
            </a:extLst>
          </p:cNvPr>
          <p:cNvSpPr txBox="1"/>
          <p:nvPr/>
        </p:nvSpPr>
        <p:spPr>
          <a:xfrm>
            <a:off x="3352800" y="3059668"/>
            <a:ext cx="473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F9C4626-4E47-6F37-AC5D-0FA06D229B0B}"/>
              </a:ext>
            </a:extLst>
          </p:cNvPr>
          <p:cNvSpPr txBox="1"/>
          <p:nvPr/>
        </p:nvSpPr>
        <p:spPr>
          <a:xfrm rot="19240516">
            <a:off x="4406347" y="1605778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LKBH5-WT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7BCEFAA-47BA-75D8-17D1-D58697F2657A}"/>
              </a:ext>
            </a:extLst>
          </p:cNvPr>
          <p:cNvSpPr txBox="1"/>
          <p:nvPr/>
        </p:nvSpPr>
        <p:spPr>
          <a:xfrm rot="19240516">
            <a:off x="3854440" y="1869747"/>
            <a:ext cx="950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WT</a:t>
            </a:r>
          </a:p>
        </p:txBody>
      </p:sp>
    </p:spTree>
    <p:extLst>
      <p:ext uri="{BB962C8B-B14F-4D97-AF65-F5344CB8AC3E}">
        <p14:creationId xmlns:p14="http://schemas.microsoft.com/office/powerpoint/2010/main" val="79798196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 descr="A picture containing text&#10;&#10;Description automatically generated">
            <a:extLst>
              <a:ext uri="{FF2B5EF4-FFF2-40B4-BE49-F238E27FC236}">
                <a16:creationId xmlns:a16="http://schemas.microsoft.com/office/drawing/2014/main" id="{D1B31E78-9846-FF66-8201-BB17A69A9F7B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5370" t="31031" r="26885" b="64820"/>
          <a:stretch/>
        </p:blipFill>
        <p:spPr>
          <a:xfrm rot="186444">
            <a:off x="3813442" y="2980477"/>
            <a:ext cx="1338210" cy="586844"/>
          </a:xfrm>
          <a:custGeom>
            <a:avLst/>
            <a:gdLst>
              <a:gd name="connsiteX0" fmla="*/ 1249951 w 1338210"/>
              <a:gd name="connsiteY0" fmla="*/ 0 h 586844"/>
              <a:gd name="connsiteX1" fmla="*/ 1310213 w 1338210"/>
              <a:gd name="connsiteY1" fmla="*/ 0 h 586844"/>
              <a:gd name="connsiteX2" fmla="*/ 1338210 w 1338210"/>
              <a:gd name="connsiteY2" fmla="*/ 515725 h 586844"/>
              <a:gd name="connsiteX3" fmla="*/ 28174 w 1338210"/>
              <a:gd name="connsiteY3" fmla="*/ 586844 h 586844"/>
              <a:gd name="connsiteX4" fmla="*/ 0 w 1338210"/>
              <a:gd name="connsiteY4" fmla="*/ 67857 h 58684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</a:cxnLst>
            <a:rect l="l" t="t" r="r" b="b"/>
            <a:pathLst>
              <a:path w="1338210" h="586844">
                <a:moveTo>
                  <a:pt x="1249951" y="0"/>
                </a:moveTo>
                <a:lnTo>
                  <a:pt x="1310213" y="0"/>
                </a:lnTo>
                <a:lnTo>
                  <a:pt x="1338210" y="515725"/>
                </a:lnTo>
                <a:lnTo>
                  <a:pt x="28174" y="586844"/>
                </a:lnTo>
                <a:lnTo>
                  <a:pt x="0" y="67857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</p:pic>
      <p:pic>
        <p:nvPicPr>
          <p:cNvPr id="8" name="Picture 7" descr="A picture containing text&#10;&#10;Description automatically generated">
            <a:extLst>
              <a:ext uri="{FF2B5EF4-FFF2-40B4-BE49-F238E27FC236}">
                <a16:creationId xmlns:a16="http://schemas.microsoft.com/office/drawing/2014/main" id="{A0BACCD4-EAF8-6278-1EA3-AB0E2951984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aturation sat="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2191" t="37222" r="30364" b="59195"/>
          <a:stretch/>
        </p:blipFill>
        <p:spPr>
          <a:xfrm>
            <a:off x="3826566" y="2383423"/>
            <a:ext cx="1311965" cy="539563"/>
          </a:xfrm>
          <a:custGeom>
            <a:avLst/>
            <a:gdLst>
              <a:gd name="connsiteX0" fmla="*/ 0 w 1311965"/>
              <a:gd name="connsiteY0" fmla="*/ 0 h 539563"/>
              <a:gd name="connsiteX1" fmla="*/ 1311965 w 1311965"/>
              <a:gd name="connsiteY1" fmla="*/ 0 h 539563"/>
              <a:gd name="connsiteX2" fmla="*/ 1311965 w 1311965"/>
              <a:gd name="connsiteY2" fmla="*/ 539563 h 539563"/>
              <a:gd name="connsiteX3" fmla="*/ 0 w 1311965"/>
              <a:gd name="connsiteY3" fmla="*/ 539563 h 539563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</a:cxnLst>
            <a:rect l="l" t="t" r="r" b="b"/>
            <a:pathLst>
              <a:path w="1311965" h="539563">
                <a:moveTo>
                  <a:pt x="0" y="0"/>
                </a:moveTo>
                <a:lnTo>
                  <a:pt x="1311965" y="0"/>
                </a:lnTo>
                <a:lnTo>
                  <a:pt x="1311965" y="539563"/>
                </a:lnTo>
                <a:lnTo>
                  <a:pt x="0" y="539563"/>
                </a:lnTo>
                <a:close/>
              </a:path>
            </a:pathLst>
          </a:custGeom>
          <a:ln>
            <a:solidFill>
              <a:schemeClr val="tx1"/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51276BED-2AB2-7A5B-E42A-2CF9BF09C46D}"/>
              </a:ext>
            </a:extLst>
          </p:cNvPr>
          <p:cNvSpPr txBox="1"/>
          <p:nvPr/>
        </p:nvSpPr>
        <p:spPr>
          <a:xfrm>
            <a:off x="5181600" y="2512764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LKBH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DDF688D-3ACB-8F96-A932-C12D34C169EF}"/>
              </a:ext>
            </a:extLst>
          </p:cNvPr>
          <p:cNvSpPr txBox="1"/>
          <p:nvPr/>
        </p:nvSpPr>
        <p:spPr>
          <a:xfrm>
            <a:off x="5181600" y="3089234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GAPDH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1576792-C9D1-D8A2-D5B0-40FAFA4933B8}"/>
              </a:ext>
            </a:extLst>
          </p:cNvPr>
          <p:cNvSpPr txBox="1"/>
          <p:nvPr/>
        </p:nvSpPr>
        <p:spPr>
          <a:xfrm>
            <a:off x="3352800" y="2498548"/>
            <a:ext cx="473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42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0207631-8292-F40D-7B57-50E9E545F9AE}"/>
              </a:ext>
            </a:extLst>
          </p:cNvPr>
          <p:cNvSpPr txBox="1"/>
          <p:nvPr/>
        </p:nvSpPr>
        <p:spPr>
          <a:xfrm>
            <a:off x="3352800" y="3059668"/>
            <a:ext cx="473766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37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00D9DED0-93E4-F3CE-EE37-F5CBD77B1745}"/>
              </a:ext>
            </a:extLst>
          </p:cNvPr>
          <p:cNvSpPr txBox="1"/>
          <p:nvPr/>
        </p:nvSpPr>
        <p:spPr>
          <a:xfrm rot="19240516">
            <a:off x="4565373" y="1605778"/>
            <a:ext cx="1828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hALKBH5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7AB6AE5C-F408-4BA4-5A8D-CE0A3708FC1D}"/>
              </a:ext>
            </a:extLst>
          </p:cNvPr>
          <p:cNvSpPr txBox="1"/>
          <p:nvPr/>
        </p:nvSpPr>
        <p:spPr>
          <a:xfrm rot="19240516">
            <a:off x="3854440" y="1869747"/>
            <a:ext cx="95084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shCON</a:t>
            </a:r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51191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7</Words>
  <Application>Microsoft Office PowerPoint</Application>
  <PresentationFormat>Widescreen</PresentationFormat>
  <Paragraphs>25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ng ye</dc:creator>
  <cp:lastModifiedBy>jing ye</cp:lastModifiedBy>
  <cp:revision>1</cp:revision>
  <dcterms:created xsi:type="dcterms:W3CDTF">2023-04-17T10:47:46Z</dcterms:created>
  <dcterms:modified xsi:type="dcterms:W3CDTF">2023-04-17T10:59:58Z</dcterms:modified>
</cp:coreProperties>
</file>